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365" r:id="rId2"/>
  </p:sldIdLst>
  <p:sldSz cx="7559675" cy="1069181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6C0A"/>
    <a:srgbClr val="77933C"/>
    <a:srgbClr val="F070B3"/>
    <a:srgbClr val="A9D18E"/>
    <a:srgbClr val="F23EDD"/>
    <a:srgbClr val="01B601"/>
    <a:srgbClr val="FF6200"/>
    <a:srgbClr val="FFD8BE"/>
    <a:srgbClr val="00B72E"/>
    <a:srgbClr val="00BF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65" autoAdjust="0"/>
    <p:restoredTop sz="95220" autoAdjust="0"/>
  </p:normalViewPr>
  <p:slideViewPr>
    <p:cSldViewPr snapToGrid="0">
      <p:cViewPr varScale="1">
        <p:scale>
          <a:sx n="54" d="100"/>
          <a:sy n="54" d="100"/>
        </p:scale>
        <p:origin x="271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3731;&#38738;\Desktop\Gdpd2\&#23454;&#39564;&#25968;&#25454;\20220527-Gdpd2-KO&#21742;&#21912;&#36896;&#27169;\20220527-OVA&#36896;&#27169;Gdpd2-KO-BALF&#32454;&#32990;&#20998;&#22411;&#32479;&#35745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不排除!$M$3</c:f>
              <c:strCache>
                <c:ptCount val="1"/>
                <c:pt idx="0">
                  <c:v>OVA XWT/Y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98E-4340-8C6B-9D15A35077F4}"/>
              </c:ext>
            </c:extLst>
          </c:dPt>
          <c:errBars>
            <c:errBarType val="plus"/>
            <c:errValType val="cust"/>
            <c:noEndCap val="0"/>
            <c:plus>
              <c:numRef>
                <c:f>不排除!$N$10:$R$10</c:f>
                <c:numCache>
                  <c:formatCode>General</c:formatCode>
                  <c:ptCount val="5"/>
                  <c:pt idx="0">
                    <c:v>41377.442332424631</c:v>
                  </c:pt>
                  <c:pt idx="1">
                    <c:v>8597.8625936797325</c:v>
                  </c:pt>
                  <c:pt idx="2">
                    <c:v>35640.238787105765</c:v>
                  </c:pt>
                  <c:pt idx="3">
                    <c:v>226.77606548724305</c:v>
                  </c:pt>
                  <c:pt idx="4">
                    <c:v>304.584719675693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不排除!$N$2:$R$2</c:f>
              <c:strCache>
                <c:ptCount val="5"/>
                <c:pt idx="0">
                  <c:v>Total cells</c:v>
                </c:pt>
                <c:pt idx="1">
                  <c:v>Macrophages</c:v>
                </c:pt>
                <c:pt idx="2">
                  <c:v>Eosinophils</c:v>
                </c:pt>
                <c:pt idx="3">
                  <c:v>Neutrophils</c:v>
                </c:pt>
                <c:pt idx="4">
                  <c:v>Lymphocytes</c:v>
                </c:pt>
              </c:strCache>
            </c:strRef>
          </c:cat>
          <c:val>
            <c:numRef>
              <c:f>不排除!$N$3:$R$3</c:f>
              <c:numCache>
                <c:formatCode>General</c:formatCode>
                <c:ptCount val="5"/>
                <c:pt idx="0">
                  <c:v>472404.06899601949</c:v>
                </c:pt>
                <c:pt idx="1">
                  <c:v>200368.91994692615</c:v>
                </c:pt>
                <c:pt idx="2">
                  <c:v>266510.80760725337</c:v>
                </c:pt>
                <c:pt idx="3">
                  <c:v>1407.4338788146836</c:v>
                </c:pt>
                <c:pt idx="4">
                  <c:v>4116.907563025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98E-4340-8C6B-9D15A35077F4}"/>
            </c:ext>
          </c:extLst>
        </c:ser>
        <c:ser>
          <c:idx val="1"/>
          <c:order val="1"/>
          <c:tx>
            <c:strRef>
              <c:f>不排除!$M$4</c:f>
              <c:strCache>
                <c:ptCount val="1"/>
                <c:pt idx="0">
                  <c:v>OVA XKO/Y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不排除!$N$11:$R$11</c:f>
                <c:numCache>
                  <c:formatCode>General</c:formatCode>
                  <c:ptCount val="5"/>
                  <c:pt idx="0">
                    <c:v>46240.43732789575</c:v>
                  </c:pt>
                  <c:pt idx="1">
                    <c:v>9602.4414999154997</c:v>
                  </c:pt>
                  <c:pt idx="2">
                    <c:v>49060.70992338848</c:v>
                  </c:pt>
                  <c:pt idx="3">
                    <c:v>451.44537129080044</c:v>
                  </c:pt>
                  <c:pt idx="4">
                    <c:v>493.094265936235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不排除!$N$2:$R$2</c:f>
              <c:strCache>
                <c:ptCount val="5"/>
                <c:pt idx="0">
                  <c:v>Total cells</c:v>
                </c:pt>
                <c:pt idx="1">
                  <c:v>Macrophages</c:v>
                </c:pt>
                <c:pt idx="2">
                  <c:v>Eosinophils</c:v>
                </c:pt>
                <c:pt idx="3">
                  <c:v>Neutrophils</c:v>
                </c:pt>
                <c:pt idx="4">
                  <c:v>Lymphocytes</c:v>
                </c:pt>
              </c:strCache>
            </c:strRef>
          </c:cat>
          <c:val>
            <c:numRef>
              <c:f>不排除!$N$4:$R$4</c:f>
              <c:numCache>
                <c:formatCode>General</c:formatCode>
                <c:ptCount val="5"/>
                <c:pt idx="0">
                  <c:v>636649.42827376781</c:v>
                </c:pt>
                <c:pt idx="1">
                  <c:v>186093.75480204154</c:v>
                </c:pt>
                <c:pt idx="2">
                  <c:v>442169.6550749116</c:v>
                </c:pt>
                <c:pt idx="3">
                  <c:v>2811.1055711457716</c:v>
                </c:pt>
                <c:pt idx="4">
                  <c:v>5574.91282566878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98E-4340-8C6B-9D15A35077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66567264"/>
        <c:axId val="1766571840"/>
      </c:barChart>
      <c:catAx>
        <c:axId val="17665672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766571840"/>
        <c:crosses val="autoZero"/>
        <c:auto val="1"/>
        <c:lblAlgn val="ctr"/>
        <c:lblOffset val="100"/>
        <c:noMultiLvlLbl val="0"/>
      </c:catAx>
      <c:valAx>
        <c:axId val="1766571840"/>
        <c:scaling>
          <c:orientation val="minMax"/>
          <c:max val="1600000"/>
        </c:scaling>
        <c:delete val="0"/>
        <c:axPos val="l"/>
        <c:numFmt formatCode="0.00E+00" sourceLinked="0"/>
        <c:majorTickMark val="out"/>
        <c:minorTickMark val="none"/>
        <c:tickLblPos val="none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766567264"/>
        <c:crosses val="autoZero"/>
        <c:crossBetween val="between"/>
        <c:majorUnit val="400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B29721-A363-4FA3-9E2C-56891A475333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F2F335-5CFE-4E61-B7FF-9AF214C2F7E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7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80"/>
            <a:ext cx="5669756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5650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7585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2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2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5"/>
            <a:ext cx="6520220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5650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8976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758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387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7" y="2620980"/>
            <a:ext cx="3213847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7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8" y="1539427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8" y="1539427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5650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89760" indent="0">
              <a:buNone/>
              <a:defRPr sz="1655"/>
            </a:lvl6pPr>
            <a:lvl7pPr marL="2267585" indent="0">
              <a:buNone/>
              <a:defRPr sz="1655"/>
            </a:lvl7pPr>
            <a:lvl8pPr marL="2646045" indent="0">
              <a:buNone/>
              <a:defRPr sz="1655"/>
            </a:lvl8pPr>
            <a:lvl9pPr marL="3023870" indent="0">
              <a:buNone/>
              <a:defRPr sz="165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2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5650" rtl="0" eaLnBrk="1" latinLnBrk="0" hangingPunct="1">
        <a:lnSpc>
          <a:spcPct val="90000"/>
        </a:lnSpc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565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899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565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75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87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55A2CF39-0E7C-6CC8-7AE9-3F6516C351DA}"/>
              </a:ext>
            </a:extLst>
          </p:cNvPr>
          <p:cNvGrpSpPr/>
          <p:nvPr/>
        </p:nvGrpSpPr>
        <p:grpSpPr>
          <a:xfrm>
            <a:off x="2601516" y="859049"/>
            <a:ext cx="2156861" cy="1503785"/>
            <a:chOff x="4583756" y="2118785"/>
            <a:chExt cx="2156861" cy="1503785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EDC19FC3-54C5-E03D-2388-EC4E5854EF96}"/>
                </a:ext>
              </a:extLst>
            </p:cNvPr>
            <p:cNvGrpSpPr/>
            <p:nvPr/>
          </p:nvGrpSpPr>
          <p:grpSpPr>
            <a:xfrm>
              <a:off x="4733622" y="2146570"/>
              <a:ext cx="2006995" cy="1476000"/>
              <a:chOff x="4733622" y="2146570"/>
              <a:chExt cx="2006995" cy="1476000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A48BFA20-A13F-076E-5DE1-618FAAD2B1B5}"/>
                  </a:ext>
                </a:extLst>
              </p:cNvPr>
              <p:cNvSpPr txBox="1"/>
              <p:nvPr/>
            </p:nvSpPr>
            <p:spPr>
              <a:xfrm>
                <a:off x="5880652" y="2259151"/>
                <a:ext cx="510329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-OVA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73414E8A-864C-E72F-393A-23EEA21B4E95}"/>
                  </a:ext>
                </a:extLst>
              </p:cNvPr>
              <p:cNvSpPr txBox="1"/>
              <p:nvPr/>
            </p:nvSpPr>
            <p:spPr>
              <a:xfrm>
                <a:off x="5911698" y="2383561"/>
                <a:ext cx="63546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KO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-OVA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8" name="图表 7">
                <a:extLst>
                  <a:ext uri="{FF2B5EF4-FFF2-40B4-BE49-F238E27FC236}">
                    <a16:creationId xmlns:a16="http://schemas.microsoft.com/office/drawing/2014/main" id="{DD8A6075-B03C-FF9C-487F-3E18CC5C237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56102502"/>
                  </p:ext>
                </p:extLst>
              </p:nvPr>
            </p:nvGraphicFramePr>
            <p:xfrm>
              <a:off x="4760617" y="2146570"/>
              <a:ext cx="1980000" cy="1476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id="{F965FDB1-12C9-7E1F-79E8-601E49B0C1DE}"/>
                  </a:ext>
                </a:extLst>
              </p:cNvPr>
              <p:cNvSpPr/>
              <p:nvPr/>
            </p:nvSpPr>
            <p:spPr>
              <a:xfrm>
                <a:off x="5840556" y="2283842"/>
                <a:ext cx="54000" cy="54000"/>
              </a:xfrm>
              <a:prstGeom prst="rect">
                <a:avLst/>
              </a:prstGeom>
              <a:solidFill>
                <a:schemeClr val="accent1">
                  <a:lumMod val="50000"/>
                </a:schemeClr>
              </a:solidFill>
              <a:ln>
                <a:solidFill>
                  <a:schemeClr val="accent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6029AC44-5D6D-3705-A321-E5EF79E9B448}"/>
                  </a:ext>
                </a:extLst>
              </p:cNvPr>
              <p:cNvSpPr/>
              <p:nvPr/>
            </p:nvSpPr>
            <p:spPr>
              <a:xfrm>
                <a:off x="5840556" y="2410963"/>
                <a:ext cx="54000" cy="54000"/>
              </a:xfrm>
              <a:prstGeom prst="rect">
                <a:avLst/>
              </a:prstGeom>
              <a:solidFill>
                <a:srgbClr val="C0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678B1F52-491A-23B4-4433-E57FC4113930}"/>
                  </a:ext>
                </a:extLst>
              </p:cNvPr>
              <p:cNvSpPr txBox="1"/>
              <p:nvPr/>
            </p:nvSpPr>
            <p:spPr>
              <a:xfrm>
                <a:off x="4733622" y="2973074"/>
                <a:ext cx="184069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EAA25F31-62A2-79BD-0C79-818C3B6AC881}"/>
                  </a:ext>
                </a:extLst>
              </p:cNvPr>
              <p:cNvSpPr txBox="1"/>
              <p:nvPr/>
            </p:nvSpPr>
            <p:spPr>
              <a:xfrm>
                <a:off x="4733622" y="2796143"/>
                <a:ext cx="184069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8AB1C444-9AFA-E1E3-1A46-20C5412C997C}"/>
                  </a:ext>
                </a:extLst>
              </p:cNvPr>
              <p:cNvSpPr txBox="1"/>
              <p:nvPr/>
            </p:nvSpPr>
            <p:spPr>
              <a:xfrm>
                <a:off x="4733622" y="2609189"/>
                <a:ext cx="184069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8D49E980-058D-B22D-7C1F-18D2D55E334E}"/>
                  </a:ext>
                </a:extLst>
              </p:cNvPr>
              <p:cNvSpPr txBox="1"/>
              <p:nvPr/>
            </p:nvSpPr>
            <p:spPr>
              <a:xfrm>
                <a:off x="4733622" y="2412927"/>
                <a:ext cx="184069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1C6686D7-E2E4-BCB9-9E01-F85C1EC16D90}"/>
                  </a:ext>
                </a:extLst>
              </p:cNvPr>
              <p:cNvSpPr txBox="1"/>
              <p:nvPr/>
            </p:nvSpPr>
            <p:spPr>
              <a:xfrm>
                <a:off x="4733622" y="2227805"/>
                <a:ext cx="184069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6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329ECDE-F43D-1097-D940-01C8DBA1BBC1}"/>
                </a:ext>
              </a:extLst>
            </p:cNvPr>
            <p:cNvSpPr txBox="1"/>
            <p:nvPr/>
          </p:nvSpPr>
          <p:spPr>
            <a:xfrm rot="16200000">
              <a:off x="4150037" y="2552504"/>
              <a:ext cx="10674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# of BALF cells(×10</a:t>
              </a:r>
              <a:r>
                <a:rPr lang="en-US" altLang="zh-CN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文本框 18">
            <a:extLst>
              <a:ext uri="{FF2B5EF4-FFF2-40B4-BE49-F238E27FC236}">
                <a16:creationId xmlns:a16="http://schemas.microsoft.com/office/drawing/2014/main" id="{46292779-0A53-6008-E602-A37097309FC9}"/>
              </a:ext>
            </a:extLst>
          </p:cNvPr>
          <p:cNvSpPr txBox="1"/>
          <p:nvPr/>
        </p:nvSpPr>
        <p:spPr>
          <a:xfrm>
            <a:off x="600332" y="2432043"/>
            <a:ext cx="6658252" cy="10751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6. Gdpd2 deficiency has no effect on BALF cells.</a:t>
            </a:r>
            <a:endParaRPr lang="zh-CN" altLang="zh-CN" sz="11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ronchoalveolar lavage fluid (BALF) harvested from ovalbumin (OVA)-challenged wild-type (WT) or OVA-challenged Gdpd2 KO (X</a:t>
            </a:r>
            <a:r>
              <a:rPr lang="en-US" altLang="zh-CN" sz="11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O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Y) male mice (n=7:7). Inflammatory cells were quantified using Hema 3 staining. Results are represented by mean ± SD.</a:t>
            </a:r>
            <a:endParaRPr lang="zh-CN" altLang="zh-CN" sz="11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9298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00" b="1" dirty="0">
            <a:solidFill>
              <a:srgbClr val="00B050"/>
            </a:solidFill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685</TotalTime>
  <Words>75</Words>
  <Application>Microsoft Office PowerPoint</Application>
  <PresentationFormat>自定义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rvel</dc:creator>
  <cp:lastModifiedBy>岳青</cp:lastModifiedBy>
  <cp:revision>1574</cp:revision>
  <cp:lastPrinted>2020-08-07T09:00:00Z</cp:lastPrinted>
  <dcterms:created xsi:type="dcterms:W3CDTF">2019-12-31T01:32:00Z</dcterms:created>
  <dcterms:modified xsi:type="dcterms:W3CDTF">2023-04-16T02:41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700</vt:lpwstr>
  </property>
  <property fmtid="{D5CDD505-2E9C-101B-9397-08002B2CF9AE}" pid="3" name="ICV">
    <vt:lpwstr>F6B2A8FAB1314C0CA40D9C07A9579253</vt:lpwstr>
  </property>
</Properties>
</file>